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FA79C-2F9A-4AD2-A954-25CA19F78B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6E9EF6-66A6-4C64-BFDC-C73DEC2BAA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E2BE1D-0D31-4526-9CF8-87ED79C66B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498E7-D778-47DE-94C3-64CC707D13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8427E1-5E2E-4D14-AA86-EB5271FDCA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909315-F792-41E0-A933-64C3EC0008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50C93-5AE4-47CA-B907-C5D7997632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C3BAF4-F237-4DBC-96BD-DAC6003666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AC0E41-4BBB-42A0-97E8-3FB09B2ABD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B6A862-4BC2-40C5-9320-37EC716601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FDF076-EA16-4E87-9FA3-E8F51F154A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A7D1D5-D04A-49E0-9B7D-748EC5F105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6A9C66-757B-4F5F-A073-AF0830D2EF4F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-1542960" y="0"/>
            <a:ext cx="8080200" cy="11052000"/>
            <a:chOff x="-1542960" y="0"/>
            <a:chExt cx="8080200" cy="11052000"/>
          </a:xfrm>
        </p:grpSpPr>
        <p:grpSp>
          <p:nvGrpSpPr>
            <p:cNvPr id="42" name=""/>
            <p:cNvGrpSpPr/>
            <p:nvPr/>
          </p:nvGrpSpPr>
          <p:grpSpPr>
            <a:xfrm>
              <a:off x="-1542960" y="324000"/>
              <a:ext cx="8080200" cy="10728000"/>
              <a:chOff x="-1542960" y="324000"/>
              <a:chExt cx="8080200" cy="10728000"/>
            </a:xfrm>
          </p:grpSpPr>
          <p:pic>
            <p:nvPicPr>
              <p:cNvPr id="43" name="圖片 2" descr=""/>
              <p:cNvPicPr/>
              <p:nvPr/>
            </p:nvPicPr>
            <p:blipFill>
              <a:blip r:embed="rId1"/>
              <a:stretch/>
            </p:blipFill>
            <p:spPr>
              <a:xfrm>
                <a:off x="511200" y="3624120"/>
                <a:ext cx="2698560" cy="2700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圖片 1" descr=""/>
              <p:cNvPicPr/>
              <p:nvPr/>
            </p:nvPicPr>
            <p:blipFill>
              <a:blip r:embed="rId2"/>
              <a:stretch/>
            </p:blipFill>
            <p:spPr>
              <a:xfrm>
                <a:off x="522360" y="873000"/>
                <a:ext cx="2700360" cy="270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弧形 15"/>
              <p:cNvSpPr/>
              <p:nvPr/>
            </p:nvSpPr>
            <p:spPr>
              <a:xfrm>
                <a:off x="-1503360" y="1573200"/>
                <a:ext cx="4003560" cy="3935520"/>
              </a:xfrm>
              <a:custGeom>
                <a:avLst/>
                <a:gdLst/>
                <a:ahLst/>
                <a:rect l="l" t="t" r="r" b="b"/>
                <a:pathLst>
                  <a:path stroke="0" w="4004355" h="3935133">
                    <a:moveTo>
                      <a:pt x="2050110" y="564"/>
                    </a:moveTo>
                    <a:cubicBezTo>
                      <a:pt x="3136896" y="26139"/>
                      <a:pt x="4004356" y="899261"/>
                      <a:pt x="4004356" y="1967567"/>
                    </a:cubicBezTo>
                    <a:lnTo>
                      <a:pt x="2002178" y="1967567"/>
                    </a:lnTo>
                    <a:lnTo>
                      <a:pt x="2050110" y="564"/>
                    </a:lnTo>
                    <a:close/>
                  </a:path>
                  <a:path fill="none" w="4004355" h="3935133">
                    <a:moveTo>
                      <a:pt x="2050110" y="564"/>
                    </a:moveTo>
                    <a:cubicBezTo>
                      <a:pt x="3136896" y="26139"/>
                      <a:pt x="4004356" y="899261"/>
                      <a:pt x="4004356" y="1967567"/>
                    </a:cubicBezTo>
                  </a:path>
                </a:pathLst>
              </a:custGeom>
              <a:noFill/>
              <a:ln w="1260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弧形 16"/>
              <p:cNvSpPr/>
              <p:nvPr/>
            </p:nvSpPr>
            <p:spPr>
              <a:xfrm>
                <a:off x="-1525680" y="4356000"/>
                <a:ext cx="4005360" cy="3935520"/>
              </a:xfrm>
              <a:custGeom>
                <a:avLst/>
                <a:gdLst/>
                <a:ahLst/>
                <a:rect l="l" t="t" r="r" b="b"/>
                <a:pathLst>
                  <a:path stroke="0" w="4004355" h="3935133">
                    <a:moveTo>
                      <a:pt x="2050110" y="564"/>
                    </a:moveTo>
                    <a:cubicBezTo>
                      <a:pt x="3136896" y="26139"/>
                      <a:pt x="4004356" y="899261"/>
                      <a:pt x="4004356" y="1967567"/>
                    </a:cubicBezTo>
                    <a:lnTo>
                      <a:pt x="2002178" y="1967567"/>
                    </a:lnTo>
                    <a:lnTo>
                      <a:pt x="2050110" y="564"/>
                    </a:lnTo>
                    <a:close/>
                  </a:path>
                  <a:path fill="none" w="4004355" h="3935133">
                    <a:moveTo>
                      <a:pt x="2050110" y="564"/>
                    </a:moveTo>
                    <a:cubicBezTo>
                      <a:pt x="3136896" y="26139"/>
                      <a:pt x="4004356" y="899261"/>
                      <a:pt x="4004356" y="1967567"/>
                    </a:cubicBezTo>
                  </a:path>
                </a:pathLst>
              </a:custGeom>
              <a:noFill/>
              <a:ln w="1260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47" name="圖片 13" descr=""/>
              <p:cNvPicPr/>
              <p:nvPr/>
            </p:nvPicPr>
            <p:blipFill>
              <a:blip r:embed="rId3"/>
              <a:stretch/>
            </p:blipFill>
            <p:spPr>
              <a:xfrm>
                <a:off x="514440" y="6384960"/>
                <a:ext cx="2700360" cy="270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8" name="弧形 17"/>
              <p:cNvSpPr/>
              <p:nvPr/>
            </p:nvSpPr>
            <p:spPr>
              <a:xfrm>
                <a:off x="-1542960" y="7118280"/>
                <a:ext cx="4003560" cy="3933720"/>
              </a:xfrm>
              <a:custGeom>
                <a:avLst/>
                <a:gdLst/>
                <a:ahLst/>
                <a:rect l="l" t="t" r="r" b="b"/>
                <a:pathLst>
                  <a:path stroke="0" w="4004355" h="3935133">
                    <a:moveTo>
                      <a:pt x="2050110" y="564"/>
                    </a:moveTo>
                    <a:cubicBezTo>
                      <a:pt x="3136896" y="26139"/>
                      <a:pt x="4004356" y="899261"/>
                      <a:pt x="4004356" y="1967567"/>
                    </a:cubicBezTo>
                    <a:lnTo>
                      <a:pt x="2002178" y="1967567"/>
                    </a:lnTo>
                    <a:lnTo>
                      <a:pt x="2050110" y="564"/>
                    </a:lnTo>
                    <a:close/>
                  </a:path>
                  <a:path fill="none" w="4004355" h="3935133">
                    <a:moveTo>
                      <a:pt x="2050110" y="564"/>
                    </a:moveTo>
                    <a:cubicBezTo>
                      <a:pt x="3136896" y="26139"/>
                      <a:pt x="4004356" y="899261"/>
                      <a:pt x="4004356" y="1967567"/>
                    </a:cubicBezTo>
                  </a:path>
                </a:pathLst>
              </a:custGeom>
              <a:noFill/>
              <a:ln w="1260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9" name="群組 22"/>
              <p:cNvGrpSpPr/>
              <p:nvPr/>
            </p:nvGrpSpPr>
            <p:grpSpPr>
              <a:xfrm>
                <a:off x="1744560" y="841320"/>
                <a:ext cx="4708800" cy="4667400"/>
                <a:chOff x="1744560" y="841320"/>
                <a:chExt cx="4708800" cy="4667400"/>
              </a:xfrm>
            </p:grpSpPr>
            <p:pic>
              <p:nvPicPr>
                <p:cNvPr id="50" name="圖片 4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3753000" y="841320"/>
                  <a:ext cx="2700360" cy="27007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1" name="弧形 18"/>
                <p:cNvSpPr/>
                <p:nvPr/>
              </p:nvSpPr>
              <p:spPr>
                <a:xfrm>
                  <a:off x="1744560" y="1572480"/>
                  <a:ext cx="4005000" cy="3936240"/>
                </a:xfrm>
                <a:custGeom>
                  <a:avLst/>
                  <a:gdLst/>
                  <a:ahLst/>
                  <a:rect l="l" t="t" r="r" b="b"/>
                  <a:pathLst>
                    <a:path stroke="0" w="4004355" h="3935133">
                      <a:moveTo>
                        <a:pt x="2050110" y="564"/>
                      </a:moveTo>
                      <a:cubicBezTo>
                        <a:pt x="3136896" y="26139"/>
                        <a:pt x="4004356" y="899261"/>
                        <a:pt x="4004356" y="1967567"/>
                      </a:cubicBezTo>
                      <a:lnTo>
                        <a:pt x="2002178" y="1967567"/>
                      </a:lnTo>
                      <a:lnTo>
                        <a:pt x="2050110" y="564"/>
                      </a:lnTo>
                      <a:close/>
                    </a:path>
                    <a:path fill="none" w="4004355" h="3935133">
                      <a:moveTo>
                        <a:pt x="2050110" y="564"/>
                      </a:moveTo>
                      <a:cubicBezTo>
                        <a:pt x="3136896" y="26139"/>
                        <a:pt x="4004356" y="899261"/>
                        <a:pt x="4004356" y="1967567"/>
                      </a:cubicBezTo>
                    </a:path>
                  </a:pathLst>
                </a:custGeom>
                <a:noFill/>
                <a:ln w="12600">
                  <a:solidFill>
                    <a:srgbClr val="ffffff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2" name="群組 24"/>
              <p:cNvGrpSpPr/>
              <p:nvPr/>
            </p:nvGrpSpPr>
            <p:grpSpPr>
              <a:xfrm>
                <a:off x="1727280" y="3613320"/>
                <a:ext cx="4726080" cy="4678200"/>
                <a:chOff x="1727280" y="3613320"/>
                <a:chExt cx="4726080" cy="4678200"/>
              </a:xfrm>
            </p:grpSpPr>
            <p:pic>
              <p:nvPicPr>
                <p:cNvPr id="53" name="圖片 9" descr="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3753720" y="3613320"/>
                  <a:ext cx="2699640" cy="26996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4" name="弧形 19"/>
                <p:cNvSpPr/>
                <p:nvPr/>
              </p:nvSpPr>
              <p:spPr>
                <a:xfrm>
                  <a:off x="1727280" y="4356720"/>
                  <a:ext cx="4003920" cy="3934800"/>
                </a:xfrm>
                <a:custGeom>
                  <a:avLst/>
                  <a:gdLst/>
                  <a:ahLst/>
                  <a:rect l="l" t="t" r="r" b="b"/>
                  <a:pathLst>
                    <a:path stroke="0" w="4004355" h="3935133">
                      <a:moveTo>
                        <a:pt x="2050110" y="564"/>
                      </a:moveTo>
                      <a:cubicBezTo>
                        <a:pt x="3136896" y="26139"/>
                        <a:pt x="4004356" y="899261"/>
                        <a:pt x="4004356" y="1967567"/>
                      </a:cubicBezTo>
                      <a:lnTo>
                        <a:pt x="2002178" y="1967567"/>
                      </a:lnTo>
                      <a:lnTo>
                        <a:pt x="2050110" y="564"/>
                      </a:lnTo>
                      <a:close/>
                    </a:path>
                    <a:path fill="none" w="4004355" h="3935133">
                      <a:moveTo>
                        <a:pt x="2050110" y="564"/>
                      </a:moveTo>
                      <a:cubicBezTo>
                        <a:pt x="3136896" y="26139"/>
                        <a:pt x="4004356" y="899261"/>
                        <a:pt x="4004356" y="1967567"/>
                      </a:cubicBezTo>
                    </a:path>
                  </a:pathLst>
                </a:custGeom>
                <a:noFill/>
                <a:ln w="12600">
                  <a:solidFill>
                    <a:srgbClr val="ffffff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5" name="群組 26"/>
              <p:cNvGrpSpPr/>
              <p:nvPr/>
            </p:nvGrpSpPr>
            <p:grpSpPr>
              <a:xfrm>
                <a:off x="1708200" y="6384960"/>
                <a:ext cx="4738680" cy="4667040"/>
                <a:chOff x="1708200" y="6384960"/>
                <a:chExt cx="4738680" cy="4667040"/>
              </a:xfrm>
            </p:grpSpPr>
            <p:pic>
              <p:nvPicPr>
                <p:cNvPr id="56" name="圖片 11" descr="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3747240" y="6384960"/>
                  <a:ext cx="2699640" cy="26996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7" name="弧形 20"/>
                <p:cNvSpPr/>
                <p:nvPr/>
              </p:nvSpPr>
              <p:spPr>
                <a:xfrm>
                  <a:off x="1708200" y="7117200"/>
                  <a:ext cx="4003920" cy="3934800"/>
                </a:xfrm>
                <a:custGeom>
                  <a:avLst/>
                  <a:gdLst/>
                  <a:ahLst/>
                  <a:rect l="l" t="t" r="r" b="b"/>
                  <a:pathLst>
                    <a:path stroke="0" w="4004355" h="3935133">
                      <a:moveTo>
                        <a:pt x="2050110" y="564"/>
                      </a:moveTo>
                      <a:cubicBezTo>
                        <a:pt x="3136896" y="26139"/>
                        <a:pt x="4004356" y="899261"/>
                        <a:pt x="4004356" y="1967567"/>
                      </a:cubicBezTo>
                      <a:lnTo>
                        <a:pt x="2002178" y="1967567"/>
                      </a:lnTo>
                      <a:lnTo>
                        <a:pt x="2050110" y="564"/>
                      </a:lnTo>
                      <a:close/>
                    </a:path>
                    <a:path fill="none" w="4004355" h="3935133">
                      <a:moveTo>
                        <a:pt x="2050110" y="564"/>
                      </a:moveTo>
                      <a:cubicBezTo>
                        <a:pt x="3136896" y="26139"/>
                        <a:pt x="4004356" y="899261"/>
                        <a:pt x="4004356" y="1967567"/>
                      </a:cubicBezTo>
                    </a:path>
                  </a:pathLst>
                </a:custGeom>
                <a:noFill/>
                <a:ln w="12600">
                  <a:solidFill>
                    <a:srgbClr val="ffffff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8" name="文字方塊 27"/>
              <p:cNvSpPr/>
              <p:nvPr/>
            </p:nvSpPr>
            <p:spPr>
              <a:xfrm>
                <a:off x="657360" y="2944800"/>
                <a:ext cx="503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Calibri"/>
                  </a:rPr>
                  <a:t>M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文字方塊 28"/>
              <p:cNvSpPr/>
              <p:nvPr/>
            </p:nvSpPr>
            <p:spPr>
              <a:xfrm>
                <a:off x="2658960" y="1139760"/>
                <a:ext cx="5050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Calibri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文字方塊 29"/>
              <p:cNvSpPr/>
              <p:nvPr/>
            </p:nvSpPr>
            <p:spPr>
              <a:xfrm>
                <a:off x="560520" y="5823000"/>
                <a:ext cx="5047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Calibri"/>
                  </a:rPr>
                  <a:t>M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文字方塊 30"/>
              <p:cNvSpPr/>
              <p:nvPr/>
            </p:nvSpPr>
            <p:spPr>
              <a:xfrm>
                <a:off x="657360" y="8478720"/>
                <a:ext cx="503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Calibri"/>
                  </a:rPr>
                  <a:t>M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文字方塊 31"/>
              <p:cNvSpPr/>
              <p:nvPr/>
            </p:nvSpPr>
            <p:spPr>
              <a:xfrm>
                <a:off x="5916600" y="1114560"/>
                <a:ext cx="503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Calibri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文字方塊 32"/>
              <p:cNvSpPr/>
              <p:nvPr/>
            </p:nvSpPr>
            <p:spPr>
              <a:xfrm>
                <a:off x="5749920" y="3851280"/>
                <a:ext cx="503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Calibri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文字方塊 33"/>
              <p:cNvSpPr/>
              <p:nvPr/>
            </p:nvSpPr>
            <p:spPr>
              <a:xfrm>
                <a:off x="5749920" y="6588000"/>
                <a:ext cx="503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Calibri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文字方塊 34"/>
              <p:cNvSpPr/>
              <p:nvPr/>
            </p:nvSpPr>
            <p:spPr>
              <a:xfrm>
                <a:off x="3968640" y="2913120"/>
                <a:ext cx="5050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Calibri"/>
                  </a:rPr>
                  <a:t>M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文字方塊 35"/>
              <p:cNvSpPr/>
              <p:nvPr/>
            </p:nvSpPr>
            <p:spPr>
              <a:xfrm>
                <a:off x="3968640" y="5823000"/>
                <a:ext cx="5050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Calibri"/>
                  </a:rPr>
                  <a:t>M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文字方塊 36"/>
              <p:cNvSpPr/>
              <p:nvPr/>
            </p:nvSpPr>
            <p:spPr>
              <a:xfrm>
                <a:off x="3927600" y="8466120"/>
                <a:ext cx="5047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Calibri"/>
                  </a:rPr>
                  <a:t>M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文字方塊 37"/>
              <p:cNvSpPr/>
              <p:nvPr/>
            </p:nvSpPr>
            <p:spPr>
              <a:xfrm>
                <a:off x="2460600" y="3780000"/>
                <a:ext cx="503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Calibri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文字方塊 38"/>
              <p:cNvSpPr/>
              <p:nvPr/>
            </p:nvSpPr>
            <p:spPr>
              <a:xfrm>
                <a:off x="2500200" y="6516720"/>
                <a:ext cx="5050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Calibri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文字方塊 39"/>
              <p:cNvSpPr/>
              <p:nvPr/>
            </p:nvSpPr>
            <p:spPr>
              <a:xfrm>
                <a:off x="1125360" y="324000"/>
                <a:ext cx="1436760" cy="459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WT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文字方塊 40"/>
              <p:cNvSpPr/>
              <p:nvPr/>
            </p:nvSpPr>
            <p:spPr>
              <a:xfrm>
                <a:off x="3789360" y="324000"/>
                <a:ext cx="2725920" cy="459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2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Wnk4</a:t>
                </a:r>
                <a:r>
                  <a:rPr b="1" lang="en-US" sz="2400" spc="-1" strike="noStrike" baseline="30000">
                    <a:solidFill>
                      <a:srgbClr val="000000"/>
                    </a:solidFill>
                    <a:latin typeface="Arial"/>
                    <a:ea typeface="Times New Roman"/>
                  </a:rPr>
                  <a:t>D561A/+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文字方塊 42"/>
              <p:cNvSpPr/>
              <p:nvPr/>
            </p:nvSpPr>
            <p:spPr>
              <a:xfrm>
                <a:off x="3728880" y="820800"/>
                <a:ext cx="28083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Nkcc2</a:t>
                </a:r>
                <a:r>
                  <a:rPr b="1" lang="en-US" sz="1800" spc="-1" strike="noStrike">
                    <a:solidFill>
                      <a:srgbClr val="c00000"/>
                    </a:solidFill>
                    <a:latin typeface="Arial"/>
                    <a:ea typeface="Times New Roman"/>
                  </a:rPr>
                  <a:t> </a:t>
                </a:r>
                <a:r>
                  <a:rPr b="1" lang="en-US" sz="18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+</a:t>
                </a:r>
                <a:r>
                  <a:rPr b="1" lang="en-US" sz="1800" spc="-1" strike="noStrike">
                    <a:solidFill>
                      <a:srgbClr val="00cc00"/>
                    </a:solidFill>
                    <a:latin typeface="Arial"/>
                    <a:ea typeface="Times New Roman"/>
                  </a:rPr>
                  <a:t>p-Nkcc2 (T96</a:t>
                </a:r>
                <a:r>
                  <a:rPr b="1" lang="en-US" sz="1800" spc="-1" strike="noStrike">
                    <a:solidFill>
                      <a:srgbClr val="00cc00"/>
                    </a:solidFill>
                    <a:latin typeface="Arial"/>
                  </a:rPr>
                  <a:t>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文字方塊 43"/>
              <p:cNvSpPr/>
              <p:nvPr/>
            </p:nvSpPr>
            <p:spPr>
              <a:xfrm>
                <a:off x="514440" y="3632040"/>
                <a:ext cx="9698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Nkcc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文字方塊 45"/>
              <p:cNvSpPr/>
              <p:nvPr/>
            </p:nvSpPr>
            <p:spPr>
              <a:xfrm>
                <a:off x="498600" y="6405480"/>
                <a:ext cx="17064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cc00"/>
                    </a:solidFill>
                    <a:latin typeface="Arial"/>
                    <a:ea typeface="Times New Roman"/>
                  </a:rPr>
                  <a:t>p-Nkcc2 (T96</a:t>
                </a:r>
                <a:r>
                  <a:rPr b="0" lang="en-US" sz="1800" spc="-1" strike="noStrike">
                    <a:solidFill>
                      <a:srgbClr val="00cc00"/>
                    </a:solidFill>
                    <a:latin typeface="Arial"/>
                  </a:rPr>
                  <a:t>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文字方塊 42"/>
              <p:cNvSpPr/>
              <p:nvPr/>
            </p:nvSpPr>
            <p:spPr>
              <a:xfrm>
                <a:off x="466560" y="878040"/>
                <a:ext cx="28083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Nkcc2</a:t>
                </a:r>
                <a:r>
                  <a:rPr b="1" lang="en-US" sz="1800" spc="-1" strike="noStrike">
                    <a:solidFill>
                      <a:srgbClr val="c00000"/>
                    </a:solidFill>
                    <a:latin typeface="Arial"/>
                    <a:ea typeface="Times New Roman"/>
                  </a:rPr>
                  <a:t> </a:t>
                </a:r>
                <a:r>
                  <a:rPr b="1" lang="en-US" sz="18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+</a:t>
                </a:r>
                <a:r>
                  <a:rPr b="1" lang="en-US" sz="1800" spc="-1" strike="noStrike">
                    <a:solidFill>
                      <a:srgbClr val="00cc00"/>
                    </a:solidFill>
                    <a:latin typeface="Arial"/>
                    <a:ea typeface="Times New Roman"/>
                  </a:rPr>
                  <a:t>p-Nkcc2 (T96</a:t>
                </a:r>
                <a:r>
                  <a:rPr b="1" lang="en-US" sz="1800" spc="-1" strike="noStrike">
                    <a:solidFill>
                      <a:srgbClr val="00cc00"/>
                    </a:solidFill>
                    <a:latin typeface="Arial"/>
                  </a:rPr>
                  <a:t>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文字方塊 43"/>
              <p:cNvSpPr/>
              <p:nvPr/>
            </p:nvSpPr>
            <p:spPr>
              <a:xfrm>
                <a:off x="3786120" y="3611520"/>
                <a:ext cx="970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Nkcc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文字方塊 45"/>
              <p:cNvSpPr/>
              <p:nvPr/>
            </p:nvSpPr>
            <p:spPr>
              <a:xfrm>
                <a:off x="3770280" y="6372360"/>
                <a:ext cx="1706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cc00"/>
                    </a:solidFill>
                    <a:latin typeface="Arial"/>
                    <a:ea typeface="Times New Roman"/>
                  </a:rPr>
                  <a:t>p-Nkcc2 (T96</a:t>
                </a:r>
                <a:r>
                  <a:rPr b="0" lang="en-US" sz="1800" spc="-1" strike="noStrike">
                    <a:solidFill>
                      <a:srgbClr val="00cc00"/>
                    </a:solidFill>
                    <a:latin typeface="Arial"/>
                  </a:rPr>
                  <a:t>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8" name=""/>
            <p:cNvSpPr/>
            <p:nvPr/>
          </p:nvSpPr>
          <p:spPr>
            <a:xfrm>
              <a:off x="260280" y="0"/>
              <a:ext cx="141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Figure S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"/>
          <p:cNvSpPr/>
          <p:nvPr/>
        </p:nvSpPr>
        <p:spPr>
          <a:xfrm>
            <a:off x="262080" y="468360"/>
            <a:ext cx="648000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800" spc="-1" strike="noStrike">
                <a:solidFill>
                  <a:srgbClr val="000000"/>
                </a:solidFill>
                <a:latin typeface="Times New Roman"/>
                <a:ea typeface="MS Mincho"/>
              </a:rPr>
              <a:t>Figure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  <a:ea typeface="MS Mincho"/>
              </a:rPr>
              <a:t>S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2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  <a:ea typeface="MS Mincho"/>
              </a:rPr>
              <a:t> 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I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MS Mincho"/>
              </a:rPr>
              <a:t>mmunofluorescence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images of Nkcc2 and p-Nkcc2(T96) in kidneys of WT and </a:t>
            </a:r>
            <a:r>
              <a:rPr b="1" i="1" lang="zh-TW" sz="1800" spc="-1" strike="noStrike">
                <a:solidFill>
                  <a:srgbClr val="000000"/>
                </a:solidFill>
                <a:latin typeface="Times New Roman"/>
              </a:rPr>
              <a:t>Wnk4</a:t>
            </a:r>
            <a:r>
              <a:rPr b="1" lang="zh-TW" sz="1800" spc="-1" strike="noStrike" baseline="30000">
                <a:solidFill>
                  <a:srgbClr val="000000"/>
                </a:solidFill>
                <a:latin typeface="Times New Roman"/>
              </a:rPr>
              <a:t>D561A/+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mice. 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  <a:ea typeface="MS Mincho"/>
              </a:rPr>
              <a:t>In WT mice, Nkcc2 (red) was dominantly expressed in the medullar (M) region and p-Nkcc2 (green) was mostly expressed in the cortical (C) region. In 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  <a:ea typeface="MS Mincho"/>
              </a:rPr>
              <a:t>Wnk4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  <a:ea typeface="MS Mincho"/>
              </a:rPr>
              <a:t>D561A/+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  <a:ea typeface="MS Mincho"/>
              </a:rPr>
              <a:t> mice, the abundance of Nkcc2 (red) in the medullar region was reduced but p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-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  <a:ea typeface="MS Mincho"/>
              </a:rPr>
              <a:t>Nkcc2(green) in the cortical region was enhanced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. The scale bars indicate 100 μ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30T05:29:45Z</dcterms:created>
  <dc:creator>PEIYI</dc:creator>
  <dc:description/>
  <dc:language>en-US</dc:language>
  <cp:lastModifiedBy>PEIYI</cp:lastModifiedBy>
  <dcterms:modified xsi:type="dcterms:W3CDTF">2013-08-14T02:52:22Z</dcterms:modified>
  <cp:revision>14</cp:revision>
  <dc:subject/>
  <dc:title>投影片 1</dc:title>
</cp:coreProperties>
</file>